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47" autoAdjust="0"/>
    <p:restoredTop sz="94660"/>
  </p:normalViewPr>
  <p:slideViewPr>
    <p:cSldViewPr snapToGrid="0">
      <p:cViewPr>
        <p:scale>
          <a:sx n="87" d="100"/>
          <a:sy n="87" d="100"/>
        </p:scale>
        <p:origin x="102" y="-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2DCCF-D8B1-4AD8-A39A-330D83454080}" type="datetimeFigureOut">
              <a:rPr lang="en-GB" smtClean="0"/>
              <a:t>1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8A95-D8C9-4C3D-A597-848F11335F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3612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2DCCF-D8B1-4AD8-A39A-330D83454080}" type="datetimeFigureOut">
              <a:rPr lang="en-GB" smtClean="0"/>
              <a:t>1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8A95-D8C9-4C3D-A597-848F11335F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9702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2DCCF-D8B1-4AD8-A39A-330D83454080}" type="datetimeFigureOut">
              <a:rPr lang="en-GB" smtClean="0"/>
              <a:t>1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8A95-D8C9-4C3D-A597-848F11335F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181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2DCCF-D8B1-4AD8-A39A-330D83454080}" type="datetimeFigureOut">
              <a:rPr lang="en-GB" smtClean="0"/>
              <a:t>1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8A95-D8C9-4C3D-A597-848F11335F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36501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2DCCF-D8B1-4AD8-A39A-330D83454080}" type="datetimeFigureOut">
              <a:rPr lang="en-GB" smtClean="0"/>
              <a:t>1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8A95-D8C9-4C3D-A597-848F11335F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7182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2DCCF-D8B1-4AD8-A39A-330D83454080}" type="datetimeFigureOut">
              <a:rPr lang="en-GB" smtClean="0"/>
              <a:t>13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8A95-D8C9-4C3D-A597-848F11335F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6243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2DCCF-D8B1-4AD8-A39A-330D83454080}" type="datetimeFigureOut">
              <a:rPr lang="en-GB" smtClean="0"/>
              <a:t>13/02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8A95-D8C9-4C3D-A597-848F11335F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1289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2DCCF-D8B1-4AD8-A39A-330D83454080}" type="datetimeFigureOut">
              <a:rPr lang="en-GB" smtClean="0"/>
              <a:t>13/02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8A95-D8C9-4C3D-A597-848F11335F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03283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2DCCF-D8B1-4AD8-A39A-330D83454080}" type="datetimeFigureOut">
              <a:rPr lang="en-GB" smtClean="0"/>
              <a:t>13/02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8A95-D8C9-4C3D-A597-848F11335F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3436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2DCCF-D8B1-4AD8-A39A-330D83454080}" type="datetimeFigureOut">
              <a:rPr lang="en-GB" smtClean="0"/>
              <a:t>13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8A95-D8C9-4C3D-A597-848F11335F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78776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2DCCF-D8B1-4AD8-A39A-330D83454080}" type="datetimeFigureOut">
              <a:rPr lang="en-GB" smtClean="0"/>
              <a:t>13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8A95-D8C9-4C3D-A597-848F11335F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548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12DCCF-D8B1-4AD8-A39A-330D83454080}" type="datetimeFigureOut">
              <a:rPr lang="en-GB" smtClean="0"/>
              <a:t>1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9B8A95-D8C9-4C3D-A597-848F11335F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30610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8" name="Content Placeholder 7"/>
          <p:cNvPicPr>
            <a:picLocks noGrp="1" noChangeAspect="1"/>
          </p:cNvPicPr>
          <p:nvPr>
            <p:ph sz="half" idx="1"/>
          </p:nvPr>
        </p:nvPicPr>
        <p:blipFill>
          <a:blip r:embed="rId2"/>
          <a:stretch>
            <a:fillRect/>
          </a:stretch>
        </p:blipFill>
        <p:spPr>
          <a:xfrm>
            <a:off x="129821" y="527405"/>
            <a:ext cx="2914650" cy="2948751"/>
          </a:xfrm>
          <a:prstGeom prst="rect">
            <a:avLst/>
          </a:prstGeom>
        </p:spPr>
      </p:pic>
      <p:pic>
        <p:nvPicPr>
          <p:cNvPr id="9" name="Content Placeholder 8"/>
          <p:cNvPicPr>
            <a:picLocks noGrp="1" noChangeAspect="1"/>
          </p:cNvPicPr>
          <p:nvPr>
            <p:ph sz="half" idx="2"/>
          </p:nvPr>
        </p:nvPicPr>
        <p:blipFill>
          <a:blip r:embed="rId3"/>
          <a:stretch>
            <a:fillRect/>
          </a:stretch>
        </p:blipFill>
        <p:spPr>
          <a:xfrm>
            <a:off x="129821" y="3476156"/>
            <a:ext cx="2914650" cy="2948751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3306" y="6424906"/>
            <a:ext cx="2840099" cy="2873329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36735" y="527405"/>
            <a:ext cx="2957513" cy="299211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32867" y="3523479"/>
            <a:ext cx="2957513" cy="2954335"/>
          </a:xfrm>
          <a:prstGeom prst="rect">
            <a:avLst/>
          </a:prstGeom>
        </p:spPr>
      </p:pic>
      <p:sp>
        <p:nvSpPr>
          <p:cNvPr id="13" name="Content Placeholder 2"/>
          <p:cNvSpPr txBox="1">
            <a:spLocks/>
          </p:cNvSpPr>
          <p:nvPr/>
        </p:nvSpPr>
        <p:spPr>
          <a:xfrm>
            <a:off x="3574346" y="6747229"/>
            <a:ext cx="3283654" cy="30137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GB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oikis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ocalisation graphs for the other parameters tested in the study. 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ll cycle time 20h, attachment parameter 0.001. 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ll cycle time 25h, attachment parameter 0.001. 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ll cycle time 30h, attachment parameter 0.001. 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ll cycle time 35h, attachment parameter 0.001. 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ll cycle time 40h, attachment parameter 0.001. 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ll cycle time 30h, attachment parameter 0.01.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ll cycle time 30h, attachment parameter 0.005. 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ll cycle time 30h, attachment parameter 0.0001.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pherical cell model, cell cycle time 30h, attachment parameter 0.001.  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ellularity at a variety of attachment thresholds.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02661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115</Words>
  <Application>Microsoft Office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OS</dc:creator>
  <cp:lastModifiedBy>UOS</cp:lastModifiedBy>
  <cp:revision>1</cp:revision>
  <dcterms:created xsi:type="dcterms:W3CDTF">2017-02-13T14:01:05Z</dcterms:created>
  <dcterms:modified xsi:type="dcterms:W3CDTF">2017-02-13T14:08:03Z</dcterms:modified>
</cp:coreProperties>
</file>